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5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E125022F-B0E2-F4F0-1146-D04EC776AED4}" name="寛木 大隅" initials="寛大" userId="cf01969a84f59b7b" providerId="Windows Live"/>
  <p188:author id="{04FF2262-9F11-EB7A-2C26-D8A2FBF56F14}" name="Koichiro Yoshino" initials="KY" userId="e6c477a935360a2d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54E6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B301B821-A1FF-4177-AEE7-76D212191A09}" styleName="中間スタイル 1 - アクセント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  <a:tblStyle styleId="{793D81CF-94F2-401A-BA57-92F5A7B2D0C5}" styleName="スタイル (中間)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616DA210-FB5B-4158-B5E0-FEB733F419BA}" styleName="スタイル (淡色)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F5AB1C69-6EDB-4FF4-983F-18BD219EF322}" styleName="中間スタイル 2 - アクセント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31348"/>
    <p:restoredTop sz="96327"/>
  </p:normalViewPr>
  <p:slideViewPr>
    <p:cSldViewPr snapToGrid="0">
      <p:cViewPr varScale="1">
        <p:scale>
          <a:sx n="65" d="100"/>
          <a:sy n="65" d="100"/>
        </p:scale>
        <p:origin x="96" y="10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microsoft.com/office/2018/10/relationships/authors" Target="authors.xml"/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7E890182-5073-C3EF-5B99-D58D985E3F2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xmlns="" id="{6559C88D-FD0A-B8CC-632D-1C297A7CDE7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7299DDE1-51E0-D988-1B8B-CDFB4169E0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53F93D-72EB-EE4E-8B2C-F3577928F38A}" type="datetimeFigureOut">
              <a:rPr kumimoji="1" lang="ja-JP" altLang="en-US" smtClean="0"/>
              <a:t>2026/4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E472D8F3-1DE9-1DDF-C80C-B33FA77B94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A928F8B6-FF22-A7CF-6867-42456DB645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9F69D-C3D7-C344-A23E-4E873393CD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8485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066B97A7-48CF-15A5-7B67-0A922AE492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xmlns="" id="{E791DE26-2131-24C6-9993-6D8FEEB7E6E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87159F5F-C874-2BB3-6F5F-AC88434F43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53F93D-72EB-EE4E-8B2C-F3577928F38A}" type="datetimeFigureOut">
              <a:rPr kumimoji="1" lang="ja-JP" altLang="en-US" smtClean="0"/>
              <a:t>2026/4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EB0AA853-6CFE-5401-AB38-170F101D11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54995C14-25BC-D150-0D31-603A709505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9F69D-C3D7-C344-A23E-4E873393CD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15998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xmlns="" id="{AF07746B-DA94-5F2D-7389-2BB1CBFD286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xmlns="" id="{4DD033BA-198E-9097-250E-676D2A5B791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A1F3AC04-D961-8B5E-9774-212F64CFC5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53F93D-72EB-EE4E-8B2C-F3577928F38A}" type="datetimeFigureOut">
              <a:rPr kumimoji="1" lang="ja-JP" altLang="en-US" smtClean="0"/>
              <a:t>2026/4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528F78D8-D174-7820-F506-B85CBBE59E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075676C8-8C20-E175-D60E-4650139B1C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9F69D-C3D7-C344-A23E-4E873393CD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93610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4C89CB42-DDBD-019B-488E-5D456A9072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D84A1E23-049D-032F-03FC-F67F828DD10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DDBF789E-5C80-53C6-F617-E7D8623FA6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53F93D-72EB-EE4E-8B2C-F3577928F38A}" type="datetimeFigureOut">
              <a:rPr kumimoji="1" lang="ja-JP" altLang="en-US" smtClean="0"/>
              <a:t>2026/4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8226858B-392F-89D7-795F-837BBD0793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E77B13FD-868B-ACB5-2037-E379E39132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9F69D-C3D7-C344-A23E-4E873393CD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12036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66851F11-5418-89F9-F5D6-511A73B232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88FD7D18-3E22-C12F-3BB0-9FC59954DE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5569B4AA-4E5E-13B4-EBA0-13C34D6CF7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53F93D-72EB-EE4E-8B2C-F3577928F38A}" type="datetimeFigureOut">
              <a:rPr kumimoji="1" lang="ja-JP" altLang="en-US" smtClean="0"/>
              <a:t>2026/4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756E8B46-5B97-8167-E036-8DFC83F250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598E12B2-30BA-90AF-720F-CB3E9282B7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9F69D-C3D7-C344-A23E-4E873393CD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56728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E8BC49FC-F265-5F40-55E0-14A792F33E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DA9D8B52-D684-B5F9-3275-CEBCB1E5B90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CDAE0C3C-8449-312B-103C-61FD38EE329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59A9EAA1-55F8-5593-9EE5-45EAADF4E2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53F93D-72EB-EE4E-8B2C-F3577928F38A}" type="datetimeFigureOut">
              <a:rPr kumimoji="1" lang="ja-JP" altLang="en-US" smtClean="0"/>
              <a:t>2026/4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B18DAE35-D55E-77E5-51B9-C1D9DB31C5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BA0CC33C-9D9F-2DD3-75EE-2847873AAC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9F69D-C3D7-C344-A23E-4E873393CD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52270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89CF1BD4-4BD0-A35E-D542-8621206505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A6D567F5-0EDE-7A8D-D4A8-66D577C28BC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60625F92-0E58-7B3D-3978-1065D1E1E71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xmlns="" id="{6386988D-6001-FD29-AC97-639462094FF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xmlns="" id="{DD04E6FA-725A-4484-2D2F-7CABF6BA2BE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xmlns="" id="{F3F559D0-0935-9B6E-5427-2876C8909A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53F93D-72EB-EE4E-8B2C-F3577928F38A}" type="datetimeFigureOut">
              <a:rPr kumimoji="1" lang="ja-JP" altLang="en-US" smtClean="0"/>
              <a:t>2026/4/6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xmlns="" id="{B7AE2811-EC04-AE94-A63B-D3A6D73684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xmlns="" id="{AAE4108A-0DAC-E66C-4B06-3C0371D12E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9F69D-C3D7-C344-A23E-4E873393CD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01396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0234061B-6FD2-35B1-363A-7DD34B0EE8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xmlns="" id="{25E64FA2-452B-C8E7-3175-0C497B135A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53F93D-72EB-EE4E-8B2C-F3577928F38A}" type="datetimeFigureOut">
              <a:rPr kumimoji="1" lang="ja-JP" altLang="en-US" smtClean="0"/>
              <a:t>2026/4/6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xmlns="" id="{1C2A2C22-03D6-0213-0C48-59E0CB77B0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xmlns="" id="{30EB34A5-978B-CF2C-B257-A0D54D59DC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9F69D-C3D7-C344-A23E-4E873393CD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66542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xmlns="" id="{F0C1C9BB-BF06-D9B9-F802-4BC72DA31B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53F93D-72EB-EE4E-8B2C-F3577928F38A}" type="datetimeFigureOut">
              <a:rPr kumimoji="1" lang="ja-JP" altLang="en-US" smtClean="0"/>
              <a:t>2026/4/6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xmlns="" id="{5A979DEC-B301-896B-0AAF-98DA4A99F3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xmlns="" id="{76210FCD-066C-5F92-C140-27C16D8643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9F69D-C3D7-C344-A23E-4E873393CD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53160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196FC9B9-BCFC-4052-2C9C-C871A4AB4B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DB11F735-0272-5670-4D05-1E13D91B120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xmlns="" id="{46089ACD-E04B-E27A-5C2B-1D6DC6E1A26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B7FCCD4B-8C73-11F0-635A-3A3B34F9B8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53F93D-72EB-EE4E-8B2C-F3577928F38A}" type="datetimeFigureOut">
              <a:rPr kumimoji="1" lang="ja-JP" altLang="en-US" smtClean="0"/>
              <a:t>2026/4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B0165AD9-3676-AA2C-FF8C-5932048B0F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DDD46ECD-6046-A70F-3EB9-12C3E01C92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9F69D-C3D7-C344-A23E-4E873393CD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8220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3354D086-0D73-4F8A-6B3F-AC7ADEFBF4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xmlns="" id="{7188987D-F669-D1A8-0D80-1214374A328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xmlns="" id="{98C37278-10E3-3967-2855-27D73F099AB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E232B5EC-C73C-243B-8C16-A262E33BEE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53F93D-72EB-EE4E-8B2C-F3577928F38A}" type="datetimeFigureOut">
              <a:rPr kumimoji="1" lang="ja-JP" altLang="en-US" smtClean="0"/>
              <a:t>2026/4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72D12E91-80E8-191A-D31B-CDBE064C05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00A58804-A0D3-9361-0FD2-73A142EA1C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9F69D-C3D7-C344-A23E-4E873393CD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56013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xmlns="" id="{42A0F4FC-4420-8A43-3564-4B41C4EE64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DE239100-60BE-010F-DB54-C377E77609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D04C1C6B-D57A-600D-B459-6115961F9B8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53F93D-72EB-EE4E-8B2C-F3577928F38A}" type="datetimeFigureOut">
              <a:rPr kumimoji="1" lang="ja-JP" altLang="en-US" smtClean="0"/>
              <a:t>2026/4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D0683B23-B0A1-683E-5F12-95946174B0D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A1F02E16-5695-F0FB-1945-43C8C57A0D2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39F69D-C3D7-C344-A23E-4E873393CD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56793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xmlns="" id="{8BB29538-0350-4655-3A99-A1B5F970B3B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タイトル 3">
            <a:extLst>
              <a:ext uri="{FF2B5EF4-FFF2-40B4-BE49-F238E27FC236}">
                <a16:creationId xmlns:a16="http://schemas.microsoft.com/office/drawing/2014/main" xmlns="" id="{81E1235D-4A05-C0CB-65F4-6B225E6650D3}"/>
              </a:ext>
            </a:extLst>
          </p:cNvPr>
          <p:cNvSpPr txBox="1">
            <a:spLocks/>
          </p:cNvSpPr>
          <p:nvPr/>
        </p:nvSpPr>
        <p:spPr>
          <a:xfrm>
            <a:off x="838200" y="4897"/>
            <a:ext cx="10515600" cy="81252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800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</a:p>
        </p:txBody>
      </p:sp>
      <p:pic>
        <p:nvPicPr>
          <p:cNvPr id="4" name="図 3" descr="グラフ, 折れ線グラフ&#10;&#10;AI 生成コンテンツは誤りを含む可能性があります。">
            <a:extLst>
              <a:ext uri="{FF2B5EF4-FFF2-40B4-BE49-F238E27FC236}">
                <a16:creationId xmlns:a16="http://schemas.microsoft.com/office/drawing/2014/main" xmlns="" id="{91D50553-ED8A-A384-F27B-42BCBF30DC1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2031" y="817419"/>
            <a:ext cx="2880000" cy="2880000"/>
          </a:xfrm>
          <a:prstGeom prst="rect">
            <a:avLst/>
          </a:prstGeom>
        </p:spPr>
      </p:pic>
      <p:pic>
        <p:nvPicPr>
          <p:cNvPr id="7" name="図 6" descr="グラフ, 折れ線グラフ&#10;&#10;AI 生成コンテンツは誤りを含む可能性があります。">
            <a:extLst>
              <a:ext uri="{FF2B5EF4-FFF2-40B4-BE49-F238E27FC236}">
                <a16:creationId xmlns:a16="http://schemas.microsoft.com/office/drawing/2014/main" xmlns="" id="{08693156-DE4A-8B6E-1385-C8D146795C9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02031" y="817419"/>
            <a:ext cx="2880000" cy="2880000"/>
          </a:xfrm>
          <a:prstGeom prst="rect">
            <a:avLst/>
          </a:prstGeom>
        </p:spPr>
      </p:pic>
      <p:pic>
        <p:nvPicPr>
          <p:cNvPr id="10" name="図 9" descr="グラフ, 折れ線グラフ&#10;&#10;AI 生成コンテンツは誤りを含む可能性があります。">
            <a:extLst>
              <a:ext uri="{FF2B5EF4-FFF2-40B4-BE49-F238E27FC236}">
                <a16:creationId xmlns:a16="http://schemas.microsoft.com/office/drawing/2014/main" xmlns="" id="{D16E718F-EB64-966C-4A3D-9489F57F9A5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82031" y="3697419"/>
            <a:ext cx="2880000" cy="2880000"/>
          </a:xfrm>
          <a:prstGeom prst="rect">
            <a:avLst/>
          </a:prstGeom>
        </p:spPr>
      </p:pic>
      <p:pic>
        <p:nvPicPr>
          <p:cNvPr id="12" name="図 11" descr="グラフ, 折れ線グラフ&#10;&#10;AI 生成コンテンツは誤りを含む可能性があります。">
            <a:extLst>
              <a:ext uri="{FF2B5EF4-FFF2-40B4-BE49-F238E27FC236}">
                <a16:creationId xmlns:a16="http://schemas.microsoft.com/office/drawing/2014/main" xmlns="" id="{F0EE99DF-E7AA-C74A-3F14-4D190433EFB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22031" y="3697419"/>
            <a:ext cx="2880000" cy="2880000"/>
          </a:xfrm>
          <a:prstGeom prst="rect">
            <a:avLst/>
          </a:prstGeom>
        </p:spPr>
      </p:pic>
      <p:pic>
        <p:nvPicPr>
          <p:cNvPr id="14" name="図 13" descr="グラフ, 折れ線グラフ&#10;&#10;AI 生成コンテンツは誤りを含む可能性があります。">
            <a:extLst>
              <a:ext uri="{FF2B5EF4-FFF2-40B4-BE49-F238E27FC236}">
                <a16:creationId xmlns:a16="http://schemas.microsoft.com/office/drawing/2014/main" xmlns="" id="{73AD4EFF-EC49-C513-F5B4-810A4DBA0D3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062031" y="817419"/>
            <a:ext cx="2880000" cy="2880000"/>
          </a:xfrm>
          <a:prstGeom prst="rect">
            <a:avLst/>
          </a:prstGeom>
        </p:spPr>
      </p:pic>
      <p:pic>
        <p:nvPicPr>
          <p:cNvPr id="16" name="図 15" descr="グラフ, 折れ線グラフ&#10;&#10;AI 生成コンテンツは誤りを含む可能性があります。">
            <a:extLst>
              <a:ext uri="{FF2B5EF4-FFF2-40B4-BE49-F238E27FC236}">
                <a16:creationId xmlns:a16="http://schemas.microsoft.com/office/drawing/2014/main" xmlns="" id="{0BA5D039-2594-F24A-00FE-640E3FA2E28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302031" y="3697419"/>
            <a:ext cx="2880000" cy="2880000"/>
          </a:xfrm>
          <a:prstGeom prst="rect">
            <a:avLst/>
          </a:prstGeom>
        </p:spPr>
      </p:pic>
      <p:pic>
        <p:nvPicPr>
          <p:cNvPr id="18" name="図 17" descr="グラフ&#10;&#10;AI 生成コンテンツは誤りを含む可能性があります。">
            <a:extLst>
              <a:ext uri="{FF2B5EF4-FFF2-40B4-BE49-F238E27FC236}">
                <a16:creationId xmlns:a16="http://schemas.microsoft.com/office/drawing/2014/main" xmlns="" id="{20B2F784-92F3-F3F3-3E7D-0892698AABB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182031" y="817419"/>
            <a:ext cx="2880000" cy="2880000"/>
          </a:xfrm>
          <a:prstGeom prst="rect">
            <a:avLst/>
          </a:prstGeom>
        </p:spPr>
      </p:pic>
      <p:pic>
        <p:nvPicPr>
          <p:cNvPr id="20" name="図 19" descr="グラフ, 折れ線グラフ&#10;&#10;AI 生成コンテンツは誤りを含む可能性があります。">
            <a:extLst>
              <a:ext uri="{FF2B5EF4-FFF2-40B4-BE49-F238E27FC236}">
                <a16:creationId xmlns:a16="http://schemas.microsoft.com/office/drawing/2014/main" xmlns="" id="{6FD33E88-DD4F-2084-161C-515C57C51F00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9062031" y="3697419"/>
            <a:ext cx="2880000" cy="2880000"/>
          </a:xfrm>
          <a:prstGeom prst="rect">
            <a:avLst/>
          </a:prstGeom>
        </p:spPr>
      </p:pic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xmlns="" id="{8416FF3F-AF32-8124-4BE3-6C3D18735DF1}"/>
              </a:ext>
            </a:extLst>
          </p:cNvPr>
          <p:cNvSpPr txBox="1"/>
          <p:nvPr/>
        </p:nvSpPr>
        <p:spPr>
          <a:xfrm>
            <a:off x="781674" y="1031631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ge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xmlns="" id="{401B0B9B-C419-6C49-885C-9F6F969BF18B}"/>
              </a:ext>
            </a:extLst>
          </p:cNvPr>
          <p:cNvSpPr txBox="1"/>
          <p:nvPr/>
        </p:nvSpPr>
        <p:spPr>
          <a:xfrm>
            <a:off x="3663716" y="1031631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BSA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xmlns="" id="{577E8373-08F6-BEE3-8587-9F6A4EA353D1}"/>
              </a:ext>
            </a:extLst>
          </p:cNvPr>
          <p:cNvSpPr txBox="1"/>
          <p:nvPr/>
        </p:nvSpPr>
        <p:spPr>
          <a:xfrm>
            <a:off x="6578983" y="1031631"/>
            <a:ext cx="13853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Eosinophil counts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xmlns="" id="{550CA846-7F88-12A0-809E-2BB65D42AA36}"/>
              </a:ext>
            </a:extLst>
          </p:cNvPr>
          <p:cNvSpPr txBox="1"/>
          <p:nvPr/>
        </p:nvSpPr>
        <p:spPr>
          <a:xfrm>
            <a:off x="9522151" y="1031631"/>
            <a:ext cx="16862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umulative OXA dose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xmlns="" id="{C7EB0816-609A-B01A-DA67-C879794BF107}"/>
              </a:ext>
            </a:extLst>
          </p:cNvPr>
          <p:cNvSpPr txBox="1"/>
          <p:nvPr/>
        </p:nvSpPr>
        <p:spPr>
          <a:xfrm>
            <a:off x="781674" y="3911630"/>
            <a:ext cx="19415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umulative dose per BSA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xmlns="" id="{51D6405C-5D5B-8E38-73B4-8F1095190458}"/>
              </a:ext>
            </a:extLst>
          </p:cNvPr>
          <p:cNvSpPr txBox="1"/>
          <p:nvPr/>
        </p:nvSpPr>
        <p:spPr>
          <a:xfrm>
            <a:off x="3663716" y="3911630"/>
            <a:ext cx="19239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umulative dose per time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xmlns="" id="{B852503A-FF41-E941-5A38-22AF47576878}"/>
              </a:ext>
            </a:extLst>
          </p:cNvPr>
          <p:cNvSpPr txBox="1"/>
          <p:nvPr/>
        </p:nvSpPr>
        <p:spPr>
          <a:xfrm>
            <a:off x="6578983" y="3911629"/>
            <a:ext cx="14814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Number of courses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xmlns="" id="{3D5B01B2-3B8E-198B-EED2-771C8EC5B722}"/>
              </a:ext>
            </a:extLst>
          </p:cNvPr>
          <p:cNvSpPr txBox="1"/>
          <p:nvPr/>
        </p:nvSpPr>
        <p:spPr>
          <a:xfrm>
            <a:off x="9522151" y="3911628"/>
            <a:ext cx="1362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OXA-free interval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634902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336</TotalTime>
  <Words>22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1 Number of courses of OXA treatment</dc:title>
  <dc:creator>吉野光一郎</dc:creator>
  <cp:lastModifiedBy>Mariselvi Pitchaya</cp:lastModifiedBy>
  <cp:revision>32</cp:revision>
  <dcterms:created xsi:type="dcterms:W3CDTF">2023-01-30T09:54:24Z</dcterms:created>
  <dcterms:modified xsi:type="dcterms:W3CDTF">2026-04-06T07:08:57Z</dcterms:modified>
</cp:coreProperties>
</file>